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60" d="100"/>
          <a:sy n="60" d="100"/>
        </p:scale>
        <p:origin x="1722" y="84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6495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8372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1612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5098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252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9692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3579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1607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4808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2199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2416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81E9CA-29F0-4207-90C3-6295CBFDE06D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D785A-98A1-48DE-AAB5-70415918E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0239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569" y="1180486"/>
            <a:ext cx="6630403" cy="9631893"/>
            <a:chOff x="-42863" y="1501328"/>
            <a:chExt cx="6881813" cy="9926217"/>
          </a:xfrm>
        </p:grpSpPr>
        <p:sp>
          <p:nvSpPr>
            <p:cNvPr id="5" name="TextBox 4"/>
            <p:cNvSpPr txBox="1"/>
            <p:nvPr/>
          </p:nvSpPr>
          <p:spPr>
            <a:xfrm>
              <a:off x="-42863" y="1501328"/>
              <a:ext cx="274626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Birth weight (minus ADA criteria studies)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1" y="1912288"/>
              <a:ext cx="3343275" cy="2353165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3386137" y="1501328"/>
              <a:ext cx="24080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 Birth weight (minus ADIPS studies)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76625" y="1939726"/>
              <a:ext cx="3295650" cy="2358425"/>
            </a:xfrm>
            <a:prstGeom prst="rect">
              <a:avLst/>
            </a:prstGeom>
          </p:spPr>
        </p:pic>
        <p:sp>
          <p:nvSpPr>
            <p:cNvPr id="10" name="Rectangle 9"/>
            <p:cNvSpPr/>
            <p:nvPr/>
          </p:nvSpPr>
          <p:spPr>
            <a:xfrm>
              <a:off x="-42863" y="5055143"/>
              <a:ext cx="2524125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Birth weight (minus ACOG studies)</a:t>
              </a: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525" y="5499291"/>
              <a:ext cx="3333750" cy="2353165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09950" y="5486970"/>
              <a:ext cx="3295650" cy="2343400"/>
            </a:xfrm>
            <a:prstGeom prst="rect">
              <a:avLst/>
            </a:prstGeom>
          </p:spPr>
        </p:pic>
        <p:sp>
          <p:nvSpPr>
            <p:cNvPr id="14" name="Rectangle 13"/>
            <p:cNvSpPr/>
            <p:nvPr/>
          </p:nvSpPr>
          <p:spPr>
            <a:xfrm>
              <a:off x="3343275" y="5057464"/>
              <a:ext cx="3429000" cy="261610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) Birth weight (minus CC studies)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-42863" y="8423903"/>
              <a:ext cx="3429000" cy="261610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) Birth weight (minus Finnish National Criteria studies)</a:t>
              </a:r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8984214"/>
              <a:ext cx="3409950" cy="2384395"/>
            </a:xfrm>
            <a:prstGeom prst="rect">
              <a:avLst/>
            </a:prstGeom>
          </p:spPr>
        </p:pic>
        <p:sp>
          <p:nvSpPr>
            <p:cNvPr id="17" name="Rectangle 16"/>
            <p:cNvSpPr/>
            <p:nvPr/>
          </p:nvSpPr>
          <p:spPr>
            <a:xfrm>
              <a:off x="3409950" y="8396557"/>
              <a:ext cx="3429000" cy="261610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) Birth weight (minus IADPSG studies)</a:t>
              </a:r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476625" y="8984214"/>
              <a:ext cx="3295650" cy="244333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249718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1353235"/>
            <a:ext cx="3429000" cy="26161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) Birth weight (minus NDDG studies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98520"/>
            <a:ext cx="3352800" cy="261325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352800" y="1328212"/>
            <a:ext cx="23455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) Birth weight (minus WHO studies)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3287" y="1798520"/>
            <a:ext cx="3324225" cy="253463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-74612" y="5083627"/>
            <a:ext cx="35782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) Birth weight (minus studies without GDM criteria details)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" y="5637096"/>
            <a:ext cx="3352800" cy="2406443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0" y="9478561"/>
            <a:ext cx="548575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: Leave-one-criteria-out analysis: Birth weight</a:t>
            </a:r>
          </a:p>
        </p:txBody>
      </p:sp>
    </p:spTree>
    <p:extLst>
      <p:ext uri="{BB962C8B-B14F-4D97-AF65-F5344CB8AC3E}">
        <p14:creationId xmlns:p14="http://schemas.microsoft.com/office/powerpoint/2010/main" val="2937184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0</TotalTime>
  <Words>95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Adkins</dc:creator>
  <cp:lastModifiedBy>Jane Adkins</cp:lastModifiedBy>
  <cp:revision>17</cp:revision>
  <cp:lastPrinted>2019-05-01T07:47:58Z</cp:lastPrinted>
  <dcterms:created xsi:type="dcterms:W3CDTF">2019-04-29T06:38:27Z</dcterms:created>
  <dcterms:modified xsi:type="dcterms:W3CDTF">2019-06-10T05:27:56Z</dcterms:modified>
</cp:coreProperties>
</file>